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7559675" cy="1069181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39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9"/>
    <p:restoredTop sz="94665"/>
  </p:normalViewPr>
  <p:slideViewPr>
    <p:cSldViewPr snapToGrid="0" snapToObjects="1" showGuides="1">
      <p:cViewPr varScale="1">
        <p:scale>
          <a:sx n="88" d="100"/>
          <a:sy n="88" d="100"/>
        </p:scale>
        <p:origin x="3616" y="184"/>
      </p:cViewPr>
      <p:guideLst>
        <p:guide orient="horz" pos="3368"/>
        <p:guide pos="39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4081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9652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7434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0550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771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8292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098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720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5752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956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2279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56CCC-3C8A-FE4D-AFAD-28EF6391CBAF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09118-2FFA-1745-80D0-A3E0EEBD78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3903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>
            <a:extLst>
              <a:ext uri="{FF2B5EF4-FFF2-40B4-BE49-F238E27FC236}">
                <a16:creationId xmlns:a16="http://schemas.microsoft.com/office/drawing/2014/main" id="{7025683E-3848-AF4D-AEDD-2841642A2DB4}"/>
              </a:ext>
            </a:extLst>
          </p:cNvPr>
          <p:cNvGrpSpPr/>
          <p:nvPr/>
        </p:nvGrpSpPr>
        <p:grpSpPr>
          <a:xfrm>
            <a:off x="1361152" y="798189"/>
            <a:ext cx="4837372" cy="5037561"/>
            <a:chOff x="1966414" y="725618"/>
            <a:chExt cx="4837372" cy="5037561"/>
          </a:xfrm>
        </p:grpSpPr>
        <p:pic>
          <p:nvPicPr>
            <p:cNvPr id="5" name="Picture 3">
              <a:extLst>
                <a:ext uri="{FF2B5EF4-FFF2-40B4-BE49-F238E27FC236}">
                  <a16:creationId xmlns:a16="http://schemas.microsoft.com/office/drawing/2014/main" id="{78BA79CC-7E1C-834E-B90D-D72F5150909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6414" y="728880"/>
              <a:ext cx="1609307" cy="162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4">
              <a:extLst>
                <a:ext uri="{FF2B5EF4-FFF2-40B4-BE49-F238E27FC236}">
                  <a16:creationId xmlns:a16="http://schemas.microsoft.com/office/drawing/2014/main" id="{AC828CDE-412C-764C-A4FA-13BE45A9684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75720" y="729666"/>
              <a:ext cx="1630728" cy="162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5">
              <a:extLst>
                <a:ext uri="{FF2B5EF4-FFF2-40B4-BE49-F238E27FC236}">
                  <a16:creationId xmlns:a16="http://schemas.microsoft.com/office/drawing/2014/main" id="{744A2A01-082D-1041-BF97-6F1577A3654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59896" y="725618"/>
              <a:ext cx="1609308" cy="162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6">
              <a:extLst>
                <a:ext uri="{FF2B5EF4-FFF2-40B4-BE49-F238E27FC236}">
                  <a16:creationId xmlns:a16="http://schemas.microsoft.com/office/drawing/2014/main" id="{EE4FB320-FF78-304D-94BC-B163EAB9265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31904" y="2467543"/>
              <a:ext cx="1571882" cy="162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Picture 7">
              <a:extLst>
                <a:ext uri="{FF2B5EF4-FFF2-40B4-BE49-F238E27FC236}">
                  <a16:creationId xmlns:a16="http://schemas.microsoft.com/office/drawing/2014/main" id="{4EF69732-2AF1-CF4C-931B-5C192F73A47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8016" y="2457072"/>
              <a:ext cx="1571881" cy="162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Picture 8">
              <a:extLst>
                <a:ext uri="{FF2B5EF4-FFF2-40B4-BE49-F238E27FC236}">
                  <a16:creationId xmlns:a16="http://schemas.microsoft.com/office/drawing/2014/main" id="{2C9C1D53-93E5-0E45-BAFF-B6AAE85FDAC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1545" y="2447887"/>
              <a:ext cx="1571881" cy="162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1" name="Connecteur droit avec flèche 10">
              <a:extLst>
                <a:ext uri="{FF2B5EF4-FFF2-40B4-BE49-F238E27FC236}">
                  <a16:creationId xmlns:a16="http://schemas.microsoft.com/office/drawing/2014/main" id="{31444216-211E-B14A-8BC8-05E5AF7326B0}"/>
                </a:ext>
              </a:extLst>
            </p:cNvPr>
            <p:cNvCxnSpPr/>
            <p:nvPr/>
          </p:nvCxnSpPr>
          <p:spPr>
            <a:xfrm>
              <a:off x="2639616" y="1268760"/>
              <a:ext cx="136815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cteur droit avec flèche 11">
              <a:extLst>
                <a:ext uri="{FF2B5EF4-FFF2-40B4-BE49-F238E27FC236}">
                  <a16:creationId xmlns:a16="http://schemas.microsoft.com/office/drawing/2014/main" id="{669B788F-D14A-E548-8642-968152497549}"/>
                </a:ext>
              </a:extLst>
            </p:cNvPr>
            <p:cNvCxnSpPr/>
            <p:nvPr/>
          </p:nvCxnSpPr>
          <p:spPr>
            <a:xfrm>
              <a:off x="4871864" y="1196752"/>
              <a:ext cx="136815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cteur droit avec flèche 12">
              <a:extLst>
                <a:ext uri="{FF2B5EF4-FFF2-40B4-BE49-F238E27FC236}">
                  <a16:creationId xmlns:a16="http://schemas.microsoft.com/office/drawing/2014/main" id="{0ACCC6F7-E912-5B4A-903B-8F049CE45582}"/>
                </a:ext>
              </a:extLst>
            </p:cNvPr>
            <p:cNvCxnSpPr>
              <a:cxnSpLocks/>
            </p:cNvCxnSpPr>
            <p:nvPr/>
          </p:nvCxnSpPr>
          <p:spPr>
            <a:xfrm>
              <a:off x="6528048" y="1916832"/>
              <a:ext cx="0" cy="7920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avec flèche 13">
              <a:extLst>
                <a:ext uri="{FF2B5EF4-FFF2-40B4-BE49-F238E27FC236}">
                  <a16:creationId xmlns:a16="http://schemas.microsoft.com/office/drawing/2014/main" id="{6369399B-0C69-0147-AD2D-4EF06A9C9688}"/>
                </a:ext>
              </a:extLst>
            </p:cNvPr>
            <p:cNvCxnSpPr/>
            <p:nvPr/>
          </p:nvCxnSpPr>
          <p:spPr>
            <a:xfrm>
              <a:off x="5008375" y="3429000"/>
              <a:ext cx="136815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cteur droit avec flèche 14">
              <a:extLst>
                <a:ext uri="{FF2B5EF4-FFF2-40B4-BE49-F238E27FC236}">
                  <a16:creationId xmlns:a16="http://schemas.microsoft.com/office/drawing/2014/main" id="{C334C2D8-8382-144B-BDD1-FA5C453E6C1D}"/>
                </a:ext>
              </a:extLst>
            </p:cNvPr>
            <p:cNvCxnSpPr>
              <a:cxnSpLocks/>
            </p:cNvCxnSpPr>
            <p:nvPr/>
          </p:nvCxnSpPr>
          <p:spPr>
            <a:xfrm>
              <a:off x="3341259" y="3573016"/>
              <a:ext cx="303526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DD20EFFF-FDEE-EE4A-AB75-8FC62D116991}"/>
                </a:ext>
              </a:extLst>
            </p:cNvPr>
            <p:cNvSpPr txBox="1"/>
            <p:nvPr/>
          </p:nvSpPr>
          <p:spPr>
            <a:xfrm>
              <a:off x="2224430" y="3645604"/>
              <a:ext cx="48719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21</a:t>
              </a:r>
              <a:r>
                <a:rPr lang="fr-FR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</a:t>
              </a:r>
            </a:p>
          </p:txBody>
        </p:sp>
        <p:grpSp>
          <p:nvGrpSpPr>
            <p:cNvPr id="17" name="Groupe 16">
              <a:extLst>
                <a:ext uri="{FF2B5EF4-FFF2-40B4-BE49-F238E27FC236}">
                  <a16:creationId xmlns:a16="http://schemas.microsoft.com/office/drawing/2014/main" id="{D08348EC-CE66-6745-BEF4-E5797E9C66EA}"/>
                </a:ext>
              </a:extLst>
            </p:cNvPr>
            <p:cNvGrpSpPr/>
            <p:nvPr/>
          </p:nvGrpSpPr>
          <p:grpSpPr>
            <a:xfrm>
              <a:off x="2003840" y="4061846"/>
              <a:ext cx="1571881" cy="1701333"/>
              <a:chOff x="426269" y="3933636"/>
              <a:chExt cx="1571881" cy="1701333"/>
            </a:xfrm>
          </p:grpSpPr>
          <p:pic>
            <p:nvPicPr>
              <p:cNvPr id="19" name="Picture 9">
                <a:extLst>
                  <a:ext uri="{FF2B5EF4-FFF2-40B4-BE49-F238E27FC236}">
                    <a16:creationId xmlns:a16="http://schemas.microsoft.com/office/drawing/2014/main" id="{E19C18A0-E230-7E40-ADB5-55062E14102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6269" y="4014969"/>
                <a:ext cx="1571881" cy="16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9DFA65A4-D1BB-F640-8597-245A79F35B3C}"/>
                  </a:ext>
                </a:extLst>
              </p:cNvPr>
              <p:cNvSpPr txBox="1"/>
              <p:nvPr/>
            </p:nvSpPr>
            <p:spPr>
              <a:xfrm>
                <a:off x="700428" y="3933636"/>
                <a:ext cx="1152128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CD21</a:t>
                </a:r>
                <a:r>
                  <a:rPr lang="fr-FR" sz="8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</a:t>
                </a:r>
                <a:r>
                  <a:rPr lang="fr-F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] CD27 / </a:t>
                </a:r>
                <a:r>
                  <a:rPr lang="fr-FR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gD</a:t>
                </a:r>
                <a:endParaRPr lang="fr-FR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E9B63A33-D0CF-4842-B1A8-3C519746A04A}"/>
                  </a:ext>
                </a:extLst>
              </p:cNvPr>
              <p:cNvSpPr txBox="1"/>
              <p:nvPr/>
            </p:nvSpPr>
            <p:spPr>
              <a:xfrm>
                <a:off x="1403648" y="5157192"/>
                <a:ext cx="360040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</a:t>
                </a:r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0D307CED-DB8A-7643-8D84-ACA4FC27C374}"/>
                  </a:ext>
                </a:extLst>
              </p:cNvPr>
              <p:cNvSpPr txBox="1"/>
              <p:nvPr/>
            </p:nvSpPr>
            <p:spPr>
              <a:xfrm>
                <a:off x="683568" y="5187410"/>
                <a:ext cx="432048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LM</a:t>
                </a:r>
              </a:p>
            </p:txBody>
          </p:sp>
        </p:grpSp>
        <p:cxnSp>
          <p:nvCxnSpPr>
            <p:cNvPr id="18" name="Connecteur droit avec flèche 17">
              <a:extLst>
                <a:ext uri="{FF2B5EF4-FFF2-40B4-BE49-F238E27FC236}">
                  <a16:creationId xmlns:a16="http://schemas.microsoft.com/office/drawing/2014/main" id="{91E11C11-AF0D-BB4F-B8DD-1F3053B6017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82306" y="3733144"/>
              <a:ext cx="1" cy="6319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Rectangle 22">
            <a:extLst>
              <a:ext uri="{FF2B5EF4-FFF2-40B4-BE49-F238E27FC236}">
                <a16:creationId xmlns:a16="http://schemas.microsoft.com/office/drawing/2014/main" id="{3B82D5A9-00BB-9F44-B388-0713FB5027C7}"/>
              </a:ext>
            </a:extLst>
          </p:cNvPr>
          <p:cNvSpPr/>
          <p:nvPr/>
        </p:nvSpPr>
        <p:spPr>
          <a:xfrm>
            <a:off x="1398578" y="5911042"/>
            <a:ext cx="4799946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4288" algn="just"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Gating strategy for the identification of blood B-cell subsets</a:t>
            </a:r>
            <a:endParaRPr lang="fr-FR" sz="1200" dirty="0">
              <a:latin typeface="Times New Roman" panose="020206030504050203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anel 4 (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able S2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was used to analyse the composition of the blood B-cell pool. Representative dot plots showing gating strategy used to identify various subsets in live CD20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-cells: Naïve B cells (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D27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or (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D21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, MZ-like B cells (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D27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, total memory B-cells (</a:t>
            </a:r>
            <a:r>
              <a:rPr lang="en-GB" sz="1200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, resting memory B-cells (RM, 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D21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hi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, activated memory (AM, 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D21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D27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)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nd tissue-like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emory (TLM, 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D21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D27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B-cells. </a:t>
            </a:r>
            <a:endParaRPr lang="fr-FR" sz="1200" dirty="0">
              <a:latin typeface="Times New Roman" panose="020206030504050203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303329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10</Words>
  <Application>Microsoft Macintosh PowerPoint</Application>
  <PresentationFormat>Personnalisé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MS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olande RICHARD</dc:creator>
  <cp:lastModifiedBy>Yolande RICHARD</cp:lastModifiedBy>
  <cp:revision>3</cp:revision>
  <dcterms:created xsi:type="dcterms:W3CDTF">2020-01-22T17:51:28Z</dcterms:created>
  <dcterms:modified xsi:type="dcterms:W3CDTF">2020-01-27T09:56:12Z</dcterms:modified>
</cp:coreProperties>
</file>